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549" r:id="rId2"/>
    <p:sldId id="550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5462"/>
  </p:normalViewPr>
  <p:slideViewPr>
    <p:cSldViewPr snapToGrid="0" snapToObjects="1">
      <p:cViewPr varScale="1">
        <p:scale>
          <a:sx n="131" d="100"/>
          <a:sy n="131" d="100"/>
        </p:scale>
        <p:origin x="162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9405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7102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8143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538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2658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837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100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8171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8191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6687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305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2BD34-7E6E-0F47-906A-457A25CB1D46}" type="datetimeFigureOut">
              <a:rPr kumimoji="1" lang="ja-JP" altLang="en-US" smtClean="0"/>
              <a:t>2022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6B35F3-F1E9-DC48-9FF0-7689A4ABE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8660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A81E805-068F-DF4E-A7A3-78D36126073C}"/>
              </a:ext>
            </a:extLst>
          </p:cNvPr>
          <p:cNvSpPr txBox="1"/>
          <p:nvPr/>
        </p:nvSpPr>
        <p:spPr>
          <a:xfrm>
            <a:off x="1454011" y="570686"/>
            <a:ext cx="6236003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ed cancer glands, isolated adjacent normal crypts and isolated distal crypts in Model A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B57DA38-BFD8-B544-AE28-72FB5C87F1F9}"/>
              </a:ext>
            </a:extLst>
          </p:cNvPr>
          <p:cNvSpPr txBox="1"/>
          <p:nvPr/>
        </p:nvSpPr>
        <p:spPr>
          <a:xfrm>
            <a:off x="831335" y="1280081"/>
            <a:ext cx="3399393" cy="156966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omprehensive miRNA analisys</a:t>
            </a:r>
          </a:p>
          <a:p>
            <a:pPr algn="ctr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Array: affymetrix GeneChip</a:t>
            </a:r>
            <a:r>
              <a:rPr lang="en-US" altLang="ja-JP" sz="1200" b="1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 miRNA Array4.0</a:t>
            </a:r>
          </a:p>
          <a:p>
            <a:pPr algn="ctr"/>
            <a:endParaRPr lang="en-US" altLang="ja-JP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84150">
              <a:tabLst>
                <a:tab pos="398463" algn="l"/>
              </a:tabLst>
            </a:pP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)	(A) Comparison of NP and ND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	(B) Comparison of T and ND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)	Mature miRNA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3)	Fold change &gt; absolute value (1.5) 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4)	FDR-p-value &lt; 0.05 (paired t-test) 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CB3DEED-FC46-584F-BA8E-E972D0CB556F}"/>
              </a:ext>
            </a:extLst>
          </p:cNvPr>
          <p:cNvSpPr txBox="1"/>
          <p:nvPr/>
        </p:nvSpPr>
        <p:spPr>
          <a:xfrm>
            <a:off x="5094026" y="1280081"/>
            <a:ext cx="3121368" cy="138499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rehensive mRNA </a:t>
            </a:r>
            <a:r>
              <a:rPr kumimoji="1"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isys</a:t>
            </a:r>
            <a:endParaRPr kumimoji="1"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ray: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fymetrix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riom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™ S human assay</a:t>
            </a:r>
          </a:p>
          <a:p>
            <a:pPr algn="ctr"/>
            <a:endParaRPr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84150">
              <a:tabLst>
                <a:tab pos="398463" algn="l"/>
              </a:tabLst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	(A) Comparison of NP and ND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(B) Comparison of T and ND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)	Fold change &gt; absolute value (1.5) 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)	FDR-p-value &lt; 0.05 (paired t-test) 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1759B15-203B-7648-92BF-B7B8253AA597}"/>
              </a:ext>
            </a:extLst>
          </p:cNvPr>
          <p:cNvSpPr txBox="1"/>
          <p:nvPr/>
        </p:nvSpPr>
        <p:spPr>
          <a:xfrm>
            <a:off x="3067605" y="3325810"/>
            <a:ext cx="3312702" cy="46166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Interaction of miRNA and mRNA</a:t>
            </a:r>
          </a:p>
          <a:p>
            <a:pPr algn="ctr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The microRNA Target Filter in IPA (QIAGEN) 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BBB83C2-BADB-3142-9A16-1A65B17963DD}"/>
              </a:ext>
            </a:extLst>
          </p:cNvPr>
          <p:cNvSpPr txBox="1"/>
          <p:nvPr/>
        </p:nvSpPr>
        <p:spPr>
          <a:xfrm>
            <a:off x="3548642" y="4629617"/>
            <a:ext cx="2438489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overy of candidate transcripts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F87F2ED-47F6-DA4A-BF0F-B24BE6EC4E82}"/>
              </a:ext>
            </a:extLst>
          </p:cNvPr>
          <p:cNvSpPr txBox="1"/>
          <p:nvPr/>
        </p:nvSpPr>
        <p:spPr>
          <a:xfrm>
            <a:off x="3294911" y="4069030"/>
            <a:ext cx="3085396" cy="276999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ression analysis for array-based analysis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A1151AB-06AB-AF40-9E82-D3B38ECF6A72}"/>
              </a:ext>
            </a:extLst>
          </p:cNvPr>
          <p:cNvSpPr txBox="1"/>
          <p:nvPr/>
        </p:nvSpPr>
        <p:spPr>
          <a:xfrm>
            <a:off x="3494420" y="5174286"/>
            <a:ext cx="2459071" cy="276999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T-PCR analysis of 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ond cohort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3980138-4E6F-0147-BF43-80A2C3825EFA}"/>
              </a:ext>
            </a:extLst>
          </p:cNvPr>
          <p:cNvSpPr txBox="1"/>
          <p:nvPr/>
        </p:nvSpPr>
        <p:spPr>
          <a:xfrm>
            <a:off x="3578124" y="5777321"/>
            <a:ext cx="2291653" cy="276999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ression analysis for RT-PCR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E8F1C799-3ECF-8B48-89F2-BB8819D5A78E}"/>
              </a:ext>
            </a:extLst>
          </p:cNvPr>
          <p:cNvCxnSpPr/>
          <p:nvPr/>
        </p:nvCxnSpPr>
        <p:spPr>
          <a:xfrm>
            <a:off x="4723954" y="3851848"/>
            <a:ext cx="0" cy="20580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50C79359-AA88-2542-8246-8A761B868834}"/>
              </a:ext>
            </a:extLst>
          </p:cNvPr>
          <p:cNvCxnSpPr/>
          <p:nvPr/>
        </p:nvCxnSpPr>
        <p:spPr>
          <a:xfrm>
            <a:off x="4730439" y="4383630"/>
            <a:ext cx="0" cy="20580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BD798219-903E-7247-BC80-E5A896690B93}"/>
              </a:ext>
            </a:extLst>
          </p:cNvPr>
          <p:cNvCxnSpPr/>
          <p:nvPr/>
        </p:nvCxnSpPr>
        <p:spPr>
          <a:xfrm>
            <a:off x="4727195" y="4925137"/>
            <a:ext cx="0" cy="20580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FF0BD1A9-1F7F-974C-8A35-365929676546}"/>
              </a:ext>
            </a:extLst>
          </p:cNvPr>
          <p:cNvCxnSpPr/>
          <p:nvPr/>
        </p:nvCxnSpPr>
        <p:spPr>
          <a:xfrm>
            <a:off x="4723951" y="5515283"/>
            <a:ext cx="0" cy="20580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下矢印 30">
            <a:extLst>
              <a:ext uri="{FF2B5EF4-FFF2-40B4-BE49-F238E27FC236}">
                <a16:creationId xmlns:a16="http://schemas.microsoft.com/office/drawing/2014/main" id="{6FDC4042-5AA5-B740-BD8C-7D3DD8EC56FA}"/>
              </a:ext>
            </a:extLst>
          </p:cNvPr>
          <p:cNvSpPr/>
          <p:nvPr/>
        </p:nvSpPr>
        <p:spPr>
          <a:xfrm>
            <a:off x="2451370" y="979771"/>
            <a:ext cx="272375" cy="30030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下矢印 31">
            <a:extLst>
              <a:ext uri="{FF2B5EF4-FFF2-40B4-BE49-F238E27FC236}">
                <a16:creationId xmlns:a16="http://schemas.microsoft.com/office/drawing/2014/main" id="{E21E7DB9-B290-AE4E-9329-8D02ACEDE530}"/>
              </a:ext>
            </a:extLst>
          </p:cNvPr>
          <p:cNvSpPr/>
          <p:nvPr/>
        </p:nvSpPr>
        <p:spPr>
          <a:xfrm>
            <a:off x="6518522" y="963261"/>
            <a:ext cx="272375" cy="30030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下矢印 32">
            <a:extLst>
              <a:ext uri="{FF2B5EF4-FFF2-40B4-BE49-F238E27FC236}">
                <a16:creationId xmlns:a16="http://schemas.microsoft.com/office/drawing/2014/main" id="{8E3E94A1-302D-6840-98CC-BAB9CC829157}"/>
              </a:ext>
            </a:extLst>
          </p:cNvPr>
          <p:cNvSpPr/>
          <p:nvPr/>
        </p:nvSpPr>
        <p:spPr>
          <a:xfrm>
            <a:off x="3067605" y="2939471"/>
            <a:ext cx="272375" cy="30030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下矢印 33">
            <a:extLst>
              <a:ext uri="{FF2B5EF4-FFF2-40B4-BE49-F238E27FC236}">
                <a16:creationId xmlns:a16="http://schemas.microsoft.com/office/drawing/2014/main" id="{1E906EAC-6FEA-FF4B-AB20-190DEE137D86}"/>
              </a:ext>
            </a:extLst>
          </p:cNvPr>
          <p:cNvSpPr/>
          <p:nvPr/>
        </p:nvSpPr>
        <p:spPr>
          <a:xfrm>
            <a:off x="5817303" y="2942773"/>
            <a:ext cx="272375" cy="30030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2603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5A4DFB3A-F0B9-5D44-A25A-E44FE749DBC0}"/>
              </a:ext>
            </a:extLst>
          </p:cNvPr>
          <p:cNvCxnSpPr/>
          <p:nvPr/>
        </p:nvCxnSpPr>
        <p:spPr>
          <a:xfrm>
            <a:off x="4289448" y="1559372"/>
            <a:ext cx="0" cy="20580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AA9B73B-F9CA-2F4C-8B3D-6614CFFAFCEE}"/>
              </a:ext>
            </a:extLst>
          </p:cNvPr>
          <p:cNvSpPr txBox="1"/>
          <p:nvPr/>
        </p:nvSpPr>
        <p:spPr>
          <a:xfrm>
            <a:off x="818960" y="1922107"/>
            <a:ext cx="3399393" cy="156966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omprehensive miRNA analisys</a:t>
            </a:r>
          </a:p>
          <a:p>
            <a:pPr algn="ctr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Array: affymetrix GeneChip</a:t>
            </a:r>
            <a:r>
              <a:rPr lang="en-US" altLang="ja-JP" sz="1200" b="1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 miRNA Array4.0</a:t>
            </a:r>
          </a:p>
          <a:p>
            <a:pPr algn="ctr"/>
            <a:endParaRPr lang="en-US" altLang="ja-JP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84150">
              <a:tabLst>
                <a:tab pos="398463" algn="l"/>
              </a:tabLst>
            </a:pP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)	(A) Comparison of NP and ND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	(B) Comparison of T and ND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)	Mature miRNA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3)	Fold change &gt; absolute value (1.5) 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4)	FDR-p-value &lt; 0.05 (paired t-test) 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337EBC3-2E08-5B4C-9483-C97A62F3D5B0}"/>
              </a:ext>
            </a:extLst>
          </p:cNvPr>
          <p:cNvSpPr txBox="1"/>
          <p:nvPr/>
        </p:nvSpPr>
        <p:spPr>
          <a:xfrm>
            <a:off x="5081651" y="1922107"/>
            <a:ext cx="3121368" cy="138499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rehensive mRNA </a:t>
            </a:r>
            <a:r>
              <a:rPr kumimoji="1"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isys</a:t>
            </a:r>
            <a:endParaRPr kumimoji="1"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ray: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fymetrix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riom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™ S human assay</a:t>
            </a:r>
          </a:p>
          <a:p>
            <a:pPr algn="ctr"/>
            <a:endParaRPr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84150">
              <a:tabLst>
                <a:tab pos="398463" algn="l"/>
              </a:tabLst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	(A) Comparison of NP and ND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(B) Comparison of T and ND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)	Fold change &gt; absolute value (1.5) </a:t>
            </a:r>
          </a:p>
          <a:p>
            <a:pPr marL="184150">
              <a:tabLst>
                <a:tab pos="398463" algn="l"/>
              </a:tabLst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)	FDR-p-value &lt; 0.05 (paired t-test) 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7BABABE-0357-BF4B-94A6-1DC64C51317C}"/>
              </a:ext>
            </a:extLst>
          </p:cNvPr>
          <p:cNvSpPr txBox="1"/>
          <p:nvPr/>
        </p:nvSpPr>
        <p:spPr>
          <a:xfrm>
            <a:off x="3055230" y="3967836"/>
            <a:ext cx="3312702" cy="46166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Interaction of miRNA and mRNA</a:t>
            </a:r>
          </a:p>
          <a:p>
            <a:pPr algn="ctr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The microRNA Target Filter in IPA (QIAGEN) 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F2A3C0D-3858-CC49-975E-5F7825878321}"/>
              </a:ext>
            </a:extLst>
          </p:cNvPr>
          <p:cNvSpPr txBox="1"/>
          <p:nvPr/>
        </p:nvSpPr>
        <p:spPr>
          <a:xfrm>
            <a:off x="3536267" y="5271643"/>
            <a:ext cx="2438489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overy of candidate transcripts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ABAA917-6DDD-8248-99A2-76B763D7AF64}"/>
              </a:ext>
            </a:extLst>
          </p:cNvPr>
          <p:cNvSpPr txBox="1"/>
          <p:nvPr/>
        </p:nvSpPr>
        <p:spPr>
          <a:xfrm>
            <a:off x="3282536" y="4711056"/>
            <a:ext cx="3085396" cy="276999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ression analysis for array-based analysis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A8C979F0-B957-ED4F-8D1A-89227716FAAD}"/>
              </a:ext>
            </a:extLst>
          </p:cNvPr>
          <p:cNvCxnSpPr/>
          <p:nvPr/>
        </p:nvCxnSpPr>
        <p:spPr>
          <a:xfrm>
            <a:off x="4711579" y="4493874"/>
            <a:ext cx="0" cy="20580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9C4DFF28-8DCC-2E4C-9505-EFB2C3095BCF}"/>
              </a:ext>
            </a:extLst>
          </p:cNvPr>
          <p:cNvCxnSpPr/>
          <p:nvPr/>
        </p:nvCxnSpPr>
        <p:spPr>
          <a:xfrm>
            <a:off x="4718064" y="5025656"/>
            <a:ext cx="0" cy="20580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下矢印 11">
            <a:extLst>
              <a:ext uri="{FF2B5EF4-FFF2-40B4-BE49-F238E27FC236}">
                <a16:creationId xmlns:a16="http://schemas.microsoft.com/office/drawing/2014/main" id="{C0F6A054-5AFB-7346-8C5E-A35718B1155C}"/>
              </a:ext>
            </a:extLst>
          </p:cNvPr>
          <p:cNvSpPr/>
          <p:nvPr/>
        </p:nvSpPr>
        <p:spPr>
          <a:xfrm>
            <a:off x="3055230" y="3581497"/>
            <a:ext cx="272375" cy="30030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下矢印 12">
            <a:extLst>
              <a:ext uri="{FF2B5EF4-FFF2-40B4-BE49-F238E27FC236}">
                <a16:creationId xmlns:a16="http://schemas.microsoft.com/office/drawing/2014/main" id="{F21BFB44-D0AF-274F-A657-DCF1CF8FF46D}"/>
              </a:ext>
            </a:extLst>
          </p:cNvPr>
          <p:cNvSpPr/>
          <p:nvPr/>
        </p:nvSpPr>
        <p:spPr>
          <a:xfrm>
            <a:off x="5804928" y="3584799"/>
            <a:ext cx="272375" cy="30030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9907AF0-6B47-CD46-9FEA-619E3496AD17}"/>
              </a:ext>
            </a:extLst>
          </p:cNvPr>
          <p:cNvSpPr txBox="1"/>
          <p:nvPr/>
        </p:nvSpPr>
        <p:spPr>
          <a:xfrm>
            <a:off x="1415100" y="1099009"/>
            <a:ext cx="6236003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ed cancer glands, isolated adjacent normal crypts and isolated distal crypts in Model B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2238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5</TotalTime>
  <Words>299</Words>
  <Application>Microsoft Macintosh PowerPoint</Application>
  <PresentationFormat>画面に合わせる (4:3)</PresentationFormat>
  <Paragraphs>4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有 菅井</dc:creator>
  <cp:lastModifiedBy>有</cp:lastModifiedBy>
  <cp:revision>12</cp:revision>
  <dcterms:created xsi:type="dcterms:W3CDTF">2022-03-22T04:50:20Z</dcterms:created>
  <dcterms:modified xsi:type="dcterms:W3CDTF">2022-03-23T23:13:34Z</dcterms:modified>
</cp:coreProperties>
</file>